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2/04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2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520714"/>
            <a:ext cx="720080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revisa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58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Molecular and pharmacokinetic features of insulin </a:t>
            </a:r>
            <a:r>
              <a:rPr lang="en-US" sz="1800" b="1" dirty="0" err="1"/>
              <a:t>icodec</a:t>
            </a:r>
            <a:r>
              <a:rPr lang="en-US" sz="1800" b="1" dirty="0"/>
              <a:t> and basal insulin Fc (BIF; insulin </a:t>
            </a:r>
            <a:r>
              <a:rPr lang="en-US" sz="1800" b="1" dirty="0" err="1"/>
              <a:t>efsitora</a:t>
            </a:r>
            <a:r>
              <a:rPr lang="en-US" sz="1800" b="1" dirty="0"/>
              <a:t> alfa)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26BAB84-F7AD-7C4C-43CF-47F4C74BA6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050" y="1124744"/>
            <a:ext cx="8528422" cy="4536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05264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revisa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158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BB23C3A-35CF-A126-0232-CE4316B480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1680" y="1213127"/>
            <a:ext cx="5760640" cy="473615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8620445-5EB3-EE58-8C99-07BAAA1B52CD}"/>
              </a:ext>
            </a:extLst>
          </p:cNvPr>
          <p:cNvSpPr txBox="1"/>
          <p:nvPr/>
        </p:nvSpPr>
        <p:spPr>
          <a:xfrm>
            <a:off x="395536" y="332656"/>
            <a:ext cx="8515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roportion of time in range (TIR) in Phase II clinical trials conducted with </a:t>
            </a:r>
            <a:r>
              <a:rPr lang="en-US" sz="2000" b="1" dirty="0" err="1"/>
              <a:t>icodec</a:t>
            </a:r>
            <a:r>
              <a:rPr lang="en-US" sz="2000" b="1" dirty="0"/>
              <a:t> (a–c) and BIF (d–f)</a:t>
            </a:r>
            <a:endParaRPr lang="en-GB" sz="20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33256"/>
            <a:ext cx="6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revisa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158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>
              <a:highlight>
                <a:srgbClr val="FFFF00"/>
              </a:highlight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515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ain results of the Phase III ONWARDS 1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–</a:t>
            </a:r>
            <a:r>
              <a:rPr lang="en-US" sz="2000" b="1" dirty="0"/>
              <a:t>6 trials of once-weekly </a:t>
            </a:r>
            <a:r>
              <a:rPr lang="en-US" sz="2000" b="1" dirty="0" err="1"/>
              <a:t>icodec</a:t>
            </a:r>
            <a:r>
              <a:rPr lang="en-US" sz="2000" b="1" dirty="0"/>
              <a:t> vs once-daily glargine, </a:t>
            </a:r>
            <a:r>
              <a:rPr lang="en-US" sz="2000" b="1" dirty="0" err="1"/>
              <a:t>degludec</a:t>
            </a:r>
            <a:r>
              <a:rPr lang="en-US" sz="2000" b="1" dirty="0"/>
              <a:t> or a basal analogue in type 1 and type 2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066AA47-3EEC-0775-A9CC-2987B4B9C8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9672" y="1229215"/>
            <a:ext cx="5893761" cy="4650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7</Words>
  <Application>Microsoft Office PowerPoint</Application>
  <PresentationFormat>On-screen Show (4:3)</PresentationFormat>
  <Paragraphs>1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4-04-22T11:43:57Z</dcterms:modified>
</cp:coreProperties>
</file>